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1DD449-2692-4A3B-9D49-5A6CCC734C7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F7D41-CEE4-4CBC-8FA3-D61AF47AB6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EF4E1D-D0E4-4C52-9910-4011130F75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78E71B-147D-4C02-8A29-CEA7762AB72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C12F07-81C0-4889-81A4-E06969359E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E7E12E-C83E-478B-B3AB-F514ED705F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105C3C-3B77-499E-B63D-ED0E2D003A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0867E9-3F83-42E0-BBF4-4ABFDDB6DB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C017DA-B821-422B-88DB-760FE73E8C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3E7012-18F4-4209-A03C-F0B8C5C564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84B3C6-9F9F-49C9-9112-0D4F46F213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1E9B58-3E14-40CC-B351-3CE20BB163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A778E87-3497-442C-93E4-09DA44C9690C}" type="datetime">
              <a:rPr b="0" lang="fr-FR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6E80D80-50C9-4167-B922-C1CA2F1E83C8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r 3"/>
          <p:cNvGrpSpPr/>
          <p:nvPr/>
        </p:nvGrpSpPr>
        <p:grpSpPr>
          <a:xfrm>
            <a:off x="-431640" y="2362320"/>
            <a:ext cx="9520920" cy="1815840"/>
            <a:chOff x="-431640" y="2362320"/>
            <a:chExt cx="9520920" cy="1815840"/>
          </a:xfrm>
        </p:grpSpPr>
        <p:grpSp>
          <p:nvGrpSpPr>
            <p:cNvPr id="42" name="Group 29"/>
            <p:cNvGrpSpPr/>
            <p:nvPr/>
          </p:nvGrpSpPr>
          <p:grpSpPr>
            <a:xfrm>
              <a:off x="-431640" y="2742840"/>
              <a:ext cx="5994360" cy="1404000"/>
              <a:chOff x="-431640" y="2742840"/>
              <a:chExt cx="5994360" cy="1404000"/>
            </a:xfrm>
          </p:grpSpPr>
          <p:sp>
            <p:nvSpPr>
              <p:cNvPr id="43" name="Text Box 5"/>
              <p:cNvSpPr/>
              <p:nvPr/>
            </p:nvSpPr>
            <p:spPr>
              <a:xfrm>
                <a:off x="685800" y="3276000"/>
                <a:ext cx="4876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fr-FR" sz="1200" spc="-1" strike="noStrike">
                    <a:solidFill>
                      <a:srgbClr val="000000"/>
                    </a:solidFill>
                    <a:latin typeface="Calibri"/>
                  </a:rPr>
                  <a:t>Time (h)                0           1         3         1        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4" name="Group 27"/>
              <p:cNvGrpSpPr/>
              <p:nvPr/>
            </p:nvGrpSpPr>
            <p:grpSpPr>
              <a:xfrm>
                <a:off x="-431640" y="2742840"/>
                <a:ext cx="4925520" cy="1404000"/>
                <a:chOff x="-431640" y="2742840"/>
                <a:chExt cx="4925520" cy="1404000"/>
              </a:xfrm>
            </p:grpSpPr>
            <p:sp>
              <p:nvSpPr>
                <p:cNvPr id="45" name="Text Box 11"/>
                <p:cNvSpPr/>
                <p:nvPr/>
              </p:nvSpPr>
              <p:spPr>
                <a:xfrm>
                  <a:off x="-431640" y="3504240"/>
                  <a:ext cx="4467240" cy="642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fr-FR" sz="1200" spc="-1" strike="noStrike">
                      <a:solidFill>
                        <a:srgbClr val="000000"/>
                      </a:solidFill>
                      <a:latin typeface="Calibri"/>
                    </a:rPr>
                    <a:t>                                 </a:t>
                  </a:r>
                  <a:r>
                    <a:rPr b="1" lang="fr-FR" sz="1200" spc="-1" strike="noStrike">
                      <a:solidFill>
                        <a:srgbClr val="000000"/>
                      </a:solidFill>
                      <a:latin typeface="Calibri"/>
                    </a:rPr>
                    <a:t>Treatment</a:t>
                  </a:r>
                  <a:r>
                    <a:rPr b="0" lang="fr-FR" sz="1800" spc="-1" strike="noStrike">
                      <a:solidFill>
                        <a:srgbClr val="000000"/>
                      </a:solidFill>
                      <a:latin typeface="Calibri"/>
                    </a:rPr>
                    <a:t>                    </a:t>
                  </a:r>
                  <a:r>
                    <a:rPr b="1" lang="fr-FR" sz="1200" spc="-1" strike="noStrike">
                      <a:solidFill>
                        <a:srgbClr val="000000"/>
                      </a:solidFill>
                      <a:latin typeface="Calibri"/>
                    </a:rPr>
                    <a:t>CM </a:t>
                  </a:r>
                  <a:r>
                    <a:rPr b="0" lang="fr-FR" sz="1800" spc="-1" strike="noStrike">
                      <a:solidFill>
                        <a:srgbClr val="000000"/>
                      </a:solidFill>
                      <a:latin typeface="Calibri"/>
                    </a:rPr>
                    <a:t>          </a:t>
                  </a:r>
                  <a:r>
                    <a:rPr b="1" lang="fr-FR" sz="1200" spc="-1" strike="noStrike">
                      <a:solidFill>
                        <a:srgbClr val="000000"/>
                      </a:solidFill>
                      <a:latin typeface="Calibri"/>
                    </a:rPr>
                    <a:t>Ins </a:t>
                  </a:r>
                  <a:r>
                    <a:rPr b="0" lang="fr-FR" sz="1800" spc="-1" strike="noStrike">
                      <a:solidFill>
                        <a:srgbClr val="000000"/>
                      </a:solidFill>
                      <a:latin typeface="Calibri"/>
                    </a:rPr>
                    <a:t>          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6" name="Group 26"/>
                <p:cNvGrpSpPr/>
                <p:nvPr/>
              </p:nvGrpSpPr>
              <p:grpSpPr>
                <a:xfrm>
                  <a:off x="609840" y="2742840"/>
                  <a:ext cx="3884040" cy="884880"/>
                  <a:chOff x="609840" y="2742840"/>
                  <a:chExt cx="3884040" cy="884880"/>
                </a:xfrm>
              </p:grpSpPr>
              <p:sp>
                <p:nvSpPr>
                  <p:cNvPr id="47" name="Text Box 6"/>
                  <p:cNvSpPr/>
                  <p:nvPr/>
                </p:nvSpPr>
                <p:spPr>
                  <a:xfrm>
                    <a:off x="609840" y="3171240"/>
                    <a:ext cx="183960" cy="45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pic>
                <p:nvPicPr>
                  <p:cNvPr id="48" name="Picture 7" descr=""/>
                  <p:cNvPicPr/>
                  <p:nvPr/>
                </p:nvPicPr>
                <p:blipFill>
                  <a:blip r:embed="rId1"/>
                  <a:stretch/>
                </p:blipFill>
                <p:spPr>
                  <a:xfrm>
                    <a:off x="1540080" y="2742840"/>
                    <a:ext cx="2133360" cy="356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49" name="Line 16"/>
                  <p:cNvSpPr/>
                  <p:nvPr/>
                </p:nvSpPr>
                <p:spPr>
                  <a:xfrm>
                    <a:off x="2171880" y="3504240"/>
                    <a:ext cx="15238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" name="Line 17"/>
                  <p:cNvSpPr/>
                  <p:nvPr/>
                </p:nvSpPr>
                <p:spPr>
                  <a:xfrm>
                    <a:off x="2171880" y="3427920"/>
                    <a:ext cx="0" cy="759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9160" bIns="29160" anchor="ctr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" name="Line 18"/>
                  <p:cNvSpPr/>
                  <p:nvPr/>
                </p:nvSpPr>
                <p:spPr>
                  <a:xfrm>
                    <a:off x="2914920" y="3427920"/>
                    <a:ext cx="0" cy="759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9160" bIns="29160" anchor="ctr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" name="Line 19"/>
                  <p:cNvSpPr/>
                  <p:nvPr/>
                </p:nvSpPr>
                <p:spPr>
                  <a:xfrm>
                    <a:off x="3708360" y="3427920"/>
                    <a:ext cx="0" cy="759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9160" bIns="29160" anchor="ctr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" name="Text Box 21"/>
                  <p:cNvSpPr/>
                  <p:nvPr/>
                </p:nvSpPr>
                <p:spPr>
                  <a:xfrm>
                    <a:off x="3964320" y="2772720"/>
                    <a:ext cx="52956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fr-FR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p-Akt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sp>
          <p:nvSpPr>
            <p:cNvPr id="54" name="ZoneTexte 35"/>
            <p:cNvSpPr/>
            <p:nvPr/>
          </p:nvSpPr>
          <p:spPr>
            <a:xfrm>
              <a:off x="468360" y="2362320"/>
              <a:ext cx="8153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Calibri"/>
                </a:rPr>
                <a:t>File.3 </a:t>
              </a:r>
              <a:r>
                <a:rPr b="1" lang="fr-FR" sz="1200" spc="-1" strike="noStrike" u="sng">
                  <a:solidFill>
                    <a:srgbClr val="000000"/>
                  </a:solidFill>
                  <a:uFillTx/>
                  <a:latin typeface="Calibri"/>
                </a:rPr>
                <a:t>Serum-deprived MCF-7 cells do not secrete autocrine factor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ZoneTexte 37"/>
            <p:cNvSpPr/>
            <p:nvPr/>
          </p:nvSpPr>
          <p:spPr>
            <a:xfrm>
              <a:off x="4793760" y="2806560"/>
              <a:ext cx="4295520" cy="1371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e cells were made quiescent in medium with ICI 182780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during 48 h. They were then placed for 6 h in fresh mediu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(serum- and phenol red-free) with ICI 182780; this was used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s conditioned medium (CM). Another series of dishes wer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imulated for 1 h or 3 h with CM or with insulin as a positive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trol, lysed and analyzed for phospho-Ser473 Akt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4T17:59:19Z</dcterms:created>
  <dc:creator>Anne-Marie</dc:creator>
  <dc:description/>
  <dc:language>en-US</dc:language>
  <cp:lastModifiedBy>Anne-Marie</cp:lastModifiedBy>
  <dcterms:modified xsi:type="dcterms:W3CDTF">2012-06-03T20:55:48Z</dcterms:modified>
  <cp:revision>6</cp:revision>
  <dc:subject/>
  <dc:title>Diapositive 1</dc:title>
</cp:coreProperties>
</file>